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8582D04-DC35-4D56-BCF7-12A98704072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B166654-3BA8-48D3-82BF-AEAD8BDA9809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793BA93-60CA-4D88-8971-66D9A735C079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3696B48-BDE9-49C0-BD6A-AD75480C7577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A3F2A0F-E4FF-4972-9193-B7E2645153E5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64FFAC4-E767-4A0A-8DB4-BBC3C004B893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ECDDC34-92EE-40C0-853A-E0BEF17F5C1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54D9D5B-27B7-4A79-9ACE-80F592535DFC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88DB0EF-D6B8-455D-BEDA-DA9AB7D78362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41C14D7-0282-4B6E-8EB1-599323CDF119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A10FEF7-AD1D-453F-B2DA-4AA251EF9C80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5088CFF-9779-4763-B3B3-BE0B09908BC7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8756CE-F6B7-4F2E-A0E5-0ADD99FA7501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13"/>
          <p:cNvSpPr/>
          <p:nvPr/>
        </p:nvSpPr>
        <p:spPr>
          <a:xfrm>
            <a:off x="1431000" y="268200"/>
            <a:ext cx="635976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. MeDIP/NimbleGen Promoter +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96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pGi Array (Tiling region): Methylation analysis of KvDMR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" name="Picture 17" descr=""/>
          <p:cNvPicPr/>
          <p:nvPr/>
        </p:nvPicPr>
        <p:blipFill>
          <a:blip r:embed="rId1"/>
          <a:stretch/>
        </p:blipFill>
        <p:spPr>
          <a:xfrm>
            <a:off x="1476360" y="836640"/>
            <a:ext cx="5832360" cy="5035680"/>
          </a:xfrm>
          <a:prstGeom prst="rect">
            <a:avLst/>
          </a:prstGeom>
          <a:ln w="0">
            <a:noFill/>
          </a:ln>
        </p:spPr>
      </p:pic>
      <p:sp>
        <p:nvSpPr>
          <p:cNvPr id="41" name="Rectangle 2"/>
          <p:cNvSpPr/>
          <p:nvPr/>
        </p:nvSpPr>
        <p:spPr>
          <a:xfrm>
            <a:off x="5148360" y="1844640"/>
            <a:ext cx="693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vDM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6095880" y="1519200"/>
            <a:ext cx="457200" cy="42721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3241800" y="2357280"/>
            <a:ext cx="1411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caled log2 rati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7313040" y="1454040"/>
            <a:ext cx="963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pG isla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7311600" y="1919160"/>
            <a:ext cx="9648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crip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7313400" y="3368520"/>
            <a:ext cx="646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rain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8"/>
          <p:cNvSpPr/>
          <p:nvPr/>
        </p:nvSpPr>
        <p:spPr>
          <a:xfrm>
            <a:off x="7313400" y="3809880"/>
            <a:ext cx="6465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rain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9"/>
          <p:cNvSpPr/>
          <p:nvPr/>
        </p:nvSpPr>
        <p:spPr>
          <a:xfrm>
            <a:off x="7313040" y="4191120"/>
            <a:ext cx="61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7313040" y="4645080"/>
            <a:ext cx="61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ver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7312320" y="5111640"/>
            <a:ext cx="70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estis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2"/>
          <p:cNvSpPr/>
          <p:nvPr/>
        </p:nvSpPr>
        <p:spPr>
          <a:xfrm>
            <a:off x="7312320" y="5578560"/>
            <a:ext cx="707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estis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"/>
          <p:cNvSpPr/>
          <p:nvPr/>
        </p:nvSpPr>
        <p:spPr>
          <a:xfrm>
            <a:off x="7313040" y="2590920"/>
            <a:ext cx="666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rt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"/>
          <p:cNvSpPr/>
          <p:nvPr/>
        </p:nvSpPr>
        <p:spPr>
          <a:xfrm>
            <a:off x="7313040" y="2987640"/>
            <a:ext cx="666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eart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47:19Z</dcterms:modified>
  <cp:revision>75</cp:revision>
  <dc:subject/>
  <dc:title>PowerPoint Presentation</dc:title>
</cp:coreProperties>
</file>